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EECE6-55FD-43A7-BF3C-0C3CE791D9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C0268-4E75-47BF-9714-349A54825F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3E4DB-6D80-4DB8-A037-354E9672F1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D0BD5-EA4C-47F8-89FE-6E7170E940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515BB-C8D7-4AEC-AB08-2DCF944BA6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A77D2-400D-490B-B4A6-B5A89C91A2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5C926-D1B6-44C0-9393-FF955D44A7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A72C1-3864-4F1B-B2D4-987E66D1E5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ED4B1-30B9-43F8-B699-4F81F9C6E5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41A77-10E1-45DD-BD6E-29A1D16BB4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CF1E3-8821-4D1F-B79D-DB1478D8E7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47F7C-8536-42F1-BD71-C3C4683CF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C3CCA1D-5058-41CE-AF1D-2CF5B79BE2A0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87B91CA-591A-45E1-BFE9-70FDCE480D7E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0" t="0" r="28751" b="31614"/>
          <a:stretch/>
        </p:blipFill>
        <p:spPr>
          <a:xfrm>
            <a:off x="104760" y="1035000"/>
            <a:ext cx="4276800" cy="27115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14"/>
          <p:cNvSpPr/>
          <p:nvPr/>
        </p:nvSpPr>
        <p:spPr>
          <a:xfrm>
            <a:off x="5543640" y="3686040"/>
            <a:ext cx="151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45RA+CD28+ Tre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15"/>
          <p:cNvSpPr/>
          <p:nvPr/>
        </p:nvSpPr>
        <p:spPr>
          <a:xfrm>
            <a:off x="7157880" y="3686040"/>
            <a:ext cx="1476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45RA-CD28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re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30"/>
          <p:cNvSpPr/>
          <p:nvPr/>
        </p:nvSpPr>
        <p:spPr>
          <a:xfrm>
            <a:off x="855720" y="3730680"/>
            <a:ext cx="75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45RA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28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31"/>
          <p:cNvSpPr/>
          <p:nvPr/>
        </p:nvSpPr>
        <p:spPr>
          <a:xfrm>
            <a:off x="1732320" y="3730680"/>
            <a:ext cx="72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45RA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28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32"/>
          <p:cNvSpPr/>
          <p:nvPr/>
        </p:nvSpPr>
        <p:spPr>
          <a:xfrm>
            <a:off x="2662560" y="3730680"/>
            <a:ext cx="72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45RA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28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33"/>
          <p:cNvSpPr/>
          <p:nvPr/>
        </p:nvSpPr>
        <p:spPr>
          <a:xfrm>
            <a:off x="3565800" y="3730680"/>
            <a:ext cx="758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45RA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D28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34"/>
          <p:cNvSpPr/>
          <p:nvPr/>
        </p:nvSpPr>
        <p:spPr>
          <a:xfrm rot="16200000">
            <a:off x="-750240" y="2284920"/>
            <a:ext cx="21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ercentage of cells among Tre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96"/>
          <p:cNvSpPr/>
          <p:nvPr/>
        </p:nvSpPr>
        <p:spPr>
          <a:xfrm>
            <a:off x="179280" y="326880"/>
            <a:ext cx="331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96"/>
          <p:cNvSpPr/>
          <p:nvPr/>
        </p:nvSpPr>
        <p:spPr>
          <a:xfrm>
            <a:off x="4585680" y="38592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3" descr=""/>
          <p:cNvPicPr/>
          <p:nvPr/>
        </p:nvPicPr>
        <p:blipFill>
          <a:blip r:embed="rId2"/>
          <a:srcRect l="6040" t="0" r="29059" b="37010"/>
          <a:stretch/>
        </p:blipFill>
        <p:spPr>
          <a:xfrm>
            <a:off x="5229360" y="1260360"/>
            <a:ext cx="3495600" cy="2438640"/>
          </a:xfrm>
          <a:prstGeom prst="rect">
            <a:avLst/>
          </a:prstGeom>
          <a:ln w="0">
            <a:noFill/>
          </a:ln>
        </p:spPr>
      </p:pic>
      <p:sp>
        <p:nvSpPr>
          <p:cNvPr id="52" name="Text Box 51"/>
          <p:cNvSpPr/>
          <p:nvPr/>
        </p:nvSpPr>
        <p:spPr>
          <a:xfrm>
            <a:off x="6546960" y="173052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Group 46"/>
          <p:cNvGrpSpPr/>
          <p:nvPr/>
        </p:nvGrpSpPr>
        <p:grpSpPr>
          <a:xfrm>
            <a:off x="5935680" y="1989000"/>
            <a:ext cx="1525320" cy="106560"/>
            <a:chOff x="5935680" y="1989000"/>
            <a:chExt cx="1525320" cy="106560"/>
          </a:xfrm>
        </p:grpSpPr>
        <p:sp>
          <p:nvSpPr>
            <p:cNvPr id="54" name="Line 47"/>
            <p:cNvSpPr/>
            <p:nvPr/>
          </p:nvSpPr>
          <p:spPr>
            <a:xfrm>
              <a:off x="5935680" y="1989000"/>
              <a:ext cx="1525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Line 48"/>
            <p:cNvSpPr/>
            <p:nvPr/>
          </p:nvSpPr>
          <p:spPr>
            <a:xfrm>
              <a:off x="5935680" y="1989000"/>
              <a:ext cx="0" cy="10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49"/>
            <p:cNvSpPr/>
            <p:nvPr/>
          </p:nvSpPr>
          <p:spPr>
            <a:xfrm>
              <a:off x="7461000" y="1989000"/>
              <a:ext cx="0" cy="10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 Box 24"/>
          <p:cNvSpPr/>
          <p:nvPr/>
        </p:nvSpPr>
        <p:spPr>
          <a:xfrm rot="16200000">
            <a:off x="4254840" y="2178360"/>
            <a:ext cx="152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ercentage of CD39+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expressing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51"/>
          <p:cNvSpPr/>
          <p:nvPr/>
        </p:nvSpPr>
        <p:spPr>
          <a:xfrm>
            <a:off x="6991200" y="133668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Group 46"/>
          <p:cNvGrpSpPr/>
          <p:nvPr/>
        </p:nvGrpSpPr>
        <p:grpSpPr>
          <a:xfrm>
            <a:off x="6380280" y="1595520"/>
            <a:ext cx="1524960" cy="106200"/>
            <a:chOff x="6380280" y="1595520"/>
            <a:chExt cx="1524960" cy="106200"/>
          </a:xfrm>
        </p:grpSpPr>
        <p:sp>
          <p:nvSpPr>
            <p:cNvPr id="60" name="Line 47"/>
            <p:cNvSpPr/>
            <p:nvPr/>
          </p:nvSpPr>
          <p:spPr>
            <a:xfrm>
              <a:off x="6380280" y="1595520"/>
              <a:ext cx="1524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48"/>
            <p:cNvSpPr/>
            <p:nvPr/>
          </p:nvSpPr>
          <p:spPr>
            <a:xfrm>
              <a:off x="6380280" y="1595520"/>
              <a:ext cx="0" cy="10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Line 49"/>
            <p:cNvSpPr/>
            <p:nvPr/>
          </p:nvSpPr>
          <p:spPr>
            <a:xfrm>
              <a:off x="7905240" y="1595520"/>
              <a:ext cx="0" cy="10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" name="Text Box 51"/>
          <p:cNvSpPr/>
          <p:nvPr/>
        </p:nvSpPr>
        <p:spPr>
          <a:xfrm>
            <a:off x="7473960" y="930240"/>
            <a:ext cx="28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46"/>
          <p:cNvGrpSpPr/>
          <p:nvPr/>
        </p:nvGrpSpPr>
        <p:grpSpPr>
          <a:xfrm>
            <a:off x="6862680" y="1189080"/>
            <a:ext cx="1525320" cy="106200"/>
            <a:chOff x="6862680" y="1189080"/>
            <a:chExt cx="1525320" cy="106200"/>
          </a:xfrm>
        </p:grpSpPr>
        <p:sp>
          <p:nvSpPr>
            <p:cNvPr id="65" name="Line 47"/>
            <p:cNvSpPr/>
            <p:nvPr/>
          </p:nvSpPr>
          <p:spPr>
            <a:xfrm>
              <a:off x="6862680" y="1189080"/>
              <a:ext cx="1525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48"/>
            <p:cNvSpPr/>
            <p:nvPr/>
          </p:nvSpPr>
          <p:spPr>
            <a:xfrm>
              <a:off x="6862680" y="1189080"/>
              <a:ext cx="0" cy="10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Line 49"/>
            <p:cNvSpPr/>
            <p:nvPr/>
          </p:nvSpPr>
          <p:spPr>
            <a:xfrm>
              <a:off x="8388000" y="1189080"/>
              <a:ext cx="0" cy="10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" name="Text Box 74"/>
          <p:cNvSpPr/>
          <p:nvPr/>
        </p:nvSpPr>
        <p:spPr>
          <a:xfrm>
            <a:off x="5620320" y="6488280"/>
            <a:ext cx="336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upplementary Figure 2. </a:t>
            </a: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Nikolova et a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2T09:19:21Z</dcterms:created>
  <dc:creator>Lelièvre Jean-Daniel</dc:creator>
  <dc:description/>
  <dc:language>en-US</dc:language>
  <cp:lastModifiedBy>Lelièvre Jean-Daniel</cp:lastModifiedBy>
  <dcterms:modified xsi:type="dcterms:W3CDTF">2010-11-22T11:04:16Z</dcterms:modified>
  <cp:revision>3</cp:revision>
  <dc:subject/>
  <dc:title>Diapositive 1</dc:title>
</cp:coreProperties>
</file>